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6"/>
  </p:notesMasterIdLst>
  <p:sldIdLst>
    <p:sldId id="265" r:id="rId5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1348"/>
    <p:restoredTop sz="96327"/>
  </p:normalViewPr>
  <p:slideViewPr>
    <p:cSldViewPr snapToGrid="0">
      <p:cViewPr varScale="1">
        <p:scale>
          <a:sx n="87" d="100"/>
          <a:sy n="87" d="100"/>
        </p:scale>
        <p:origin x="227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5EE78E-609C-944D-BC96-311BC06ED1B1}" type="datetimeFigureOut">
              <a:rPr lang="en-US" smtClean="0"/>
              <a:t>5/1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6102F7-0347-B24A-9C15-15BFC7C2D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198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7A467CD-930B-F04F-9134-95946BDC874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2389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7710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849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144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2487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94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533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0072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4821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77719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5107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0207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9A9C6-12A9-E34D-8D86-85EBA284C9BF}" type="datetimeFigureOut">
              <a:rPr lang="en-US" smtClean="0"/>
              <a:t>5/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01E801-ACD5-1744-86CE-BA719D32F7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7314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2C1F2639-8144-1286-F6E9-7CFB4C06846D}"/>
              </a:ext>
            </a:extLst>
          </p:cNvPr>
          <p:cNvGraphicFramePr>
            <a:graphicFrameLocks noGrp="1"/>
          </p:cNvGraphicFramePr>
          <p:nvPr/>
        </p:nvGraphicFramePr>
        <p:xfrm>
          <a:off x="534990" y="244696"/>
          <a:ext cx="5089063" cy="4636023"/>
        </p:xfrm>
        <a:graphic>
          <a:graphicData uri="http://schemas.openxmlformats.org/drawingml/2006/table">
            <a:tbl>
              <a:tblPr bandRow="1">
                <a:tableStyleId>{C083E6E3-FA7D-4D7B-A595-EF9225AFEA82}</a:tableStyleId>
              </a:tblPr>
              <a:tblGrid>
                <a:gridCol w="858983">
                  <a:extLst>
                    <a:ext uri="{9D8B030D-6E8A-4147-A177-3AD203B41FA5}">
                      <a16:colId xmlns:a16="http://schemas.microsoft.com/office/drawing/2014/main" val="1113824850"/>
                    </a:ext>
                  </a:extLst>
                </a:gridCol>
                <a:gridCol w="528760">
                  <a:extLst>
                    <a:ext uri="{9D8B030D-6E8A-4147-A177-3AD203B41FA5}">
                      <a16:colId xmlns:a16="http://schemas.microsoft.com/office/drawing/2014/main" val="1188581274"/>
                    </a:ext>
                  </a:extLst>
                </a:gridCol>
                <a:gridCol w="528760">
                  <a:extLst>
                    <a:ext uri="{9D8B030D-6E8A-4147-A177-3AD203B41FA5}">
                      <a16:colId xmlns:a16="http://schemas.microsoft.com/office/drawing/2014/main" val="941135348"/>
                    </a:ext>
                  </a:extLst>
                </a:gridCol>
                <a:gridCol w="528760">
                  <a:extLst>
                    <a:ext uri="{9D8B030D-6E8A-4147-A177-3AD203B41FA5}">
                      <a16:colId xmlns:a16="http://schemas.microsoft.com/office/drawing/2014/main" val="3700613539"/>
                    </a:ext>
                  </a:extLst>
                </a:gridCol>
                <a:gridCol w="528760">
                  <a:extLst>
                    <a:ext uri="{9D8B030D-6E8A-4147-A177-3AD203B41FA5}">
                      <a16:colId xmlns:a16="http://schemas.microsoft.com/office/drawing/2014/main" val="2193859009"/>
                    </a:ext>
                  </a:extLst>
                </a:gridCol>
                <a:gridCol w="528760">
                  <a:extLst>
                    <a:ext uri="{9D8B030D-6E8A-4147-A177-3AD203B41FA5}">
                      <a16:colId xmlns:a16="http://schemas.microsoft.com/office/drawing/2014/main" val="990171121"/>
                    </a:ext>
                  </a:extLst>
                </a:gridCol>
                <a:gridCol w="528760">
                  <a:extLst>
                    <a:ext uri="{9D8B030D-6E8A-4147-A177-3AD203B41FA5}">
                      <a16:colId xmlns:a16="http://schemas.microsoft.com/office/drawing/2014/main" val="2156160545"/>
                    </a:ext>
                  </a:extLst>
                </a:gridCol>
                <a:gridCol w="528760">
                  <a:extLst>
                    <a:ext uri="{9D8B030D-6E8A-4147-A177-3AD203B41FA5}">
                      <a16:colId xmlns:a16="http://schemas.microsoft.com/office/drawing/2014/main" val="253293946"/>
                    </a:ext>
                  </a:extLst>
                </a:gridCol>
                <a:gridCol w="528760">
                  <a:extLst>
                    <a:ext uri="{9D8B030D-6E8A-4147-A177-3AD203B41FA5}">
                      <a16:colId xmlns:a16="http://schemas.microsoft.com/office/drawing/2014/main" val="3448405554"/>
                    </a:ext>
                  </a:extLst>
                </a:gridCol>
              </a:tblGrid>
              <a:tr h="171308">
                <a:tc gridSpan="9"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ble S4. Percentage of group 3-MB cells expressing each type I MAG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</a:rPr>
                        <a:t>% of cells expressing each (type I) MAG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62396154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pe I MAGEs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V1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17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917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617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V29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H1205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V34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H825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4613691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A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153101903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A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310664028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A2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.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1894077386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A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.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.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714303319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A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2025166202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A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825402512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A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.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1903325993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A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2315226896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A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1669615425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A9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3259178098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A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4026231313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A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3953415523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A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1478666245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B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917655820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B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2442500282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B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1061613836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B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1874854377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B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2072887677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B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2750253352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B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2299959063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B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3608135828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B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2823377420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C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2735546270"/>
                  </a:ext>
                </a:extLst>
              </a:tr>
              <a:tr h="171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C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/>
                </a:tc>
                <a:extLst>
                  <a:ext uri="{0D108BD9-81ED-4DB2-BD59-A6C34878D82A}">
                    <a16:rowId xmlns:a16="http://schemas.microsoft.com/office/drawing/2014/main" val="1232911525"/>
                  </a:ext>
                </a:extLst>
              </a:tr>
              <a:tr h="1820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EC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30" marR="8030" marT="803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3997735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94257E57-D078-C89C-BD53-A157EDAA58AE}"/>
              </a:ext>
            </a:extLst>
          </p:cNvPr>
          <p:cNvSpPr txBox="1"/>
          <p:nvPr/>
        </p:nvSpPr>
        <p:spPr>
          <a:xfrm>
            <a:off x="3189887" y="9719846"/>
            <a:ext cx="13152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Supp. Table 4</a:t>
            </a:r>
          </a:p>
        </p:txBody>
      </p:sp>
    </p:spTree>
    <p:extLst>
      <p:ext uri="{BB962C8B-B14F-4D97-AF65-F5344CB8AC3E}">
        <p14:creationId xmlns:p14="http://schemas.microsoft.com/office/powerpoint/2010/main" val="21339572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80fe2a34-9ed1-467a-aea7-88d0586c3294">
      <Terms xmlns="http://schemas.microsoft.com/office/infopath/2007/PartnerControls"/>
    </lcf76f155ced4ddcb4097134ff3c332f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02CDDD2EDEB75439D8D4E2B9FCF50D0" ma:contentTypeVersion="14" ma:contentTypeDescription="Create a new document." ma:contentTypeScope="" ma:versionID="87d620ee415522c6010d2637fb198116">
  <xsd:schema xmlns:xsd="http://www.w3.org/2001/XMLSchema" xmlns:xs="http://www.w3.org/2001/XMLSchema" xmlns:p="http://schemas.microsoft.com/office/2006/metadata/properties" xmlns:ns2="80fe2a34-9ed1-467a-aea7-88d0586c3294" xmlns:ns3="a96831b6-935d-4da2-9a33-4d9a35328e51" targetNamespace="http://schemas.microsoft.com/office/2006/metadata/properties" ma:root="true" ma:fieldsID="ecef77f0a34e0062b1ddee8748364306" ns2:_="" ns3:_="">
    <xsd:import namespace="80fe2a34-9ed1-467a-aea7-88d0586c3294"/>
    <xsd:import namespace="a96831b6-935d-4da2-9a33-4d9a35328e51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lcf76f155ced4ddcb4097134ff3c332f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Location" minOccurs="0"/>
                <xsd:element ref="ns2:MediaServiceSearchProperties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0fe2a34-9ed1-467a-aea7-88d0586c329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4" nillable="true" ma:taxonomy="true" ma:internalName="lcf76f155ced4ddcb4097134ff3c332f" ma:taxonomyFieldName="MediaServiceImageTags" ma:displayName="Image Tags" ma:readOnly="false" ma:fieldId="{5cf76f15-5ced-4ddc-b409-7134ff3c332f}" ma:taxonomyMulti="true" ma:sspId="f7c65ed7-e385-4001-9a0e-797913405518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Location" ma:index="19" nillable="true" ma:displayName="Location" ma:indexed="true" ma:internalName="MediaServiceLocation" ma:readOnly="true">
      <xsd:simpleType>
        <xsd:restriction base="dms:Text"/>
      </xsd:simpleType>
    </xsd:element>
    <xsd:element name="MediaServiceSearchProperties" ma:index="2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96831b6-935d-4da2-9a33-4d9a35328e51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BA452F5-6950-4A8E-B673-A7EB80C7AC54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97D873F3-BE27-46B5-B6C1-1A6AB32CFF2B}">
  <ds:schemaRefs>
    <ds:schemaRef ds:uri="http://schemas.microsoft.com/office/2006/metadata/properties"/>
    <ds:schemaRef ds:uri="http://schemas.microsoft.com/office/infopath/2007/PartnerControls"/>
    <ds:schemaRef ds:uri="80fe2a34-9ed1-467a-aea7-88d0586c3294"/>
  </ds:schemaRefs>
</ds:datastoreItem>
</file>

<file path=customXml/itemProps3.xml><?xml version="1.0" encoding="utf-8"?>
<ds:datastoreItem xmlns:ds="http://schemas.openxmlformats.org/officeDocument/2006/customXml" ds:itemID="{3439A014-3B74-4CF9-82E9-470093E860F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0fe2a34-9ed1-467a-aea7-88d0586c3294"/>
    <ds:schemaRef ds:uri="a96831b6-935d-4da2-9a33-4d9a35328e5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9527</TotalTime>
  <Words>254</Words>
  <Application>Microsoft Macintosh PowerPoint</Application>
  <PresentationFormat>Custom</PresentationFormat>
  <Paragraphs>23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e, Rebecca</dc:creator>
  <cp:lastModifiedBy>Fon Tacer, Klementina</cp:lastModifiedBy>
  <cp:revision>32</cp:revision>
  <dcterms:created xsi:type="dcterms:W3CDTF">2024-05-10T20:09:48Z</dcterms:created>
  <dcterms:modified xsi:type="dcterms:W3CDTF">2025-05-01T21:10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02CDDD2EDEB75439D8D4E2B9FCF50D0</vt:lpwstr>
  </property>
</Properties>
</file>